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5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C6AFDD-AE33-4FAA-9856-37479E8FA5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67D4B-DFED-44E0-BDB7-949D2A1E4C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DE791-56FF-41CC-81A4-B86597D5E5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DEB65-6789-47BA-86CA-C5BE6EC181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CD2AE-BED6-427A-81F0-0350474367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D54B7-4E3A-4E33-B3A7-F5D1F18373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04A5F-A5F0-42C2-B6DF-D8B1635AD1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90571-5448-42B9-8EE9-523AE28ACE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07F4D9-EAF7-4D59-9351-283F3A091F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A74E26-B7CC-488C-8D07-1F80128849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95E36F-64D3-4A00-A267-93371389F6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286D02-A72D-41D1-8D94-18F03034A6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3575B1-1B79-49D6-8F04-C048E9F1330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1447920" y="990360"/>
            <a:ext cx="6400800" cy="556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Screen shots from the SVCMC Intranet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Addendum to the Paper: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Building and Growing the Hospital Intranet: a Case Study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© J Med Internet Res 2001 (http://www.jmir.org)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Primary author: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Kenneth R. Ong, MD, MPH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Email: kong@cmcny.com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rcRect l="0" t="0" r="0" b="33333"/>
          <a:stretch/>
        </p:blipFill>
        <p:spPr>
          <a:xfrm>
            <a:off x="990720" y="1219320"/>
            <a:ext cx="7619760" cy="3809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rcRect l="0" t="0" r="0" b="12669"/>
          <a:stretch/>
        </p:blipFill>
        <p:spPr>
          <a:xfrm>
            <a:off x="990720" y="990720"/>
            <a:ext cx="7619760" cy="4991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rcRect l="0" t="0" r="0" b="30001"/>
          <a:stretch/>
        </p:blipFill>
        <p:spPr>
          <a:xfrm>
            <a:off x="838080" y="1447920"/>
            <a:ext cx="7620120" cy="4000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rcRect l="0" t="0" r="0" b="27336"/>
          <a:stretch/>
        </p:blipFill>
        <p:spPr>
          <a:xfrm>
            <a:off x="838080" y="1219320"/>
            <a:ext cx="7620120" cy="4152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762120" y="571680"/>
            <a:ext cx="7619760" cy="57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rcRect l="0" t="0" r="0" b="19335"/>
          <a:stretch/>
        </p:blipFill>
        <p:spPr>
          <a:xfrm>
            <a:off x="762120" y="1143000"/>
            <a:ext cx="7619760" cy="4610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rcRect l="0" t="0" r="0" b="5998"/>
          <a:stretch/>
        </p:blipFill>
        <p:spPr>
          <a:xfrm>
            <a:off x="762120" y="685800"/>
            <a:ext cx="7619760" cy="5372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rcRect l="0" t="0" r="0" b="34001"/>
          <a:stretch/>
        </p:blipFill>
        <p:spPr>
          <a:xfrm>
            <a:off x="762120" y="1523880"/>
            <a:ext cx="7619760" cy="3772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rcRect l="0" t="0" r="0" b="8001"/>
          <a:stretch/>
        </p:blipFill>
        <p:spPr>
          <a:xfrm>
            <a:off x="914400" y="762120"/>
            <a:ext cx="7620120" cy="5257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rcRect l="0" t="0" r="0" b="14666"/>
          <a:stretch/>
        </p:blipFill>
        <p:spPr>
          <a:xfrm>
            <a:off x="838080" y="838080"/>
            <a:ext cx="7620120" cy="4876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rcRect l="0" t="32666" r="0" b="0"/>
          <a:stretch/>
        </p:blipFill>
        <p:spPr>
          <a:xfrm>
            <a:off x="914400" y="1447920"/>
            <a:ext cx="7620120" cy="3848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1-03-19T14:23:34Z</dcterms:created>
  <dc:creator>kong</dc:creator>
  <dc:description/>
  <dc:language>en-US</dc:language>
  <cp:lastModifiedBy>Eysenbach</cp:lastModifiedBy>
  <dcterms:modified xsi:type="dcterms:W3CDTF">2001-03-19T15:46:34Z</dcterms:modified>
  <cp:revision>2</cp:revision>
  <dc:subject/>
  <dc:title>PowerPoint Presentation</dc:title>
</cp:coreProperties>
</file>